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3060700" cy="8461375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3918" y="-72"/>
      </p:cViewPr>
      <p:guideLst>
        <p:guide orient="horz" pos="2665"/>
        <p:guide pos="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E3A8E6-4B7D-4149-BE71-A51EBA8523CD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725738" y="744538"/>
            <a:ext cx="13462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B8657C-D165-4370-823E-93D3BABC477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7850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5B8657C-D165-4370-823E-93D3BABC477C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46386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29553" y="2628511"/>
            <a:ext cx="2601595" cy="181371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459105" y="4794779"/>
            <a:ext cx="2142490" cy="216235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9829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0559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2219007" y="338848"/>
            <a:ext cx="688658" cy="721959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153035" y="338848"/>
            <a:ext cx="2014961" cy="721959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7942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1420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41774" y="5437218"/>
            <a:ext cx="2601595" cy="168052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41774" y="3586292"/>
            <a:ext cx="2601595" cy="185092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1860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153035" y="1974322"/>
            <a:ext cx="1351809" cy="55841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555856" y="1974322"/>
            <a:ext cx="1351809" cy="55841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3168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53035" y="1894017"/>
            <a:ext cx="1352341" cy="78933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53035" y="2683352"/>
            <a:ext cx="1352341" cy="487508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1554793" y="1894017"/>
            <a:ext cx="1352872" cy="78933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1554793" y="2683352"/>
            <a:ext cx="1352872" cy="487508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3734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5858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6622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3035" y="336888"/>
            <a:ext cx="1006949" cy="143373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1196649" y="336889"/>
            <a:ext cx="1711016" cy="722154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53035" y="1770622"/>
            <a:ext cx="1006949" cy="578781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4706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99919" y="5922963"/>
            <a:ext cx="1836420" cy="6992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99919" y="756040"/>
            <a:ext cx="1836420" cy="50768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599919" y="6622202"/>
            <a:ext cx="1836420" cy="9930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341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153035" y="338847"/>
            <a:ext cx="2754630" cy="14102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53035" y="1974322"/>
            <a:ext cx="2754630" cy="55841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153035" y="7842442"/>
            <a:ext cx="714163" cy="4504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045739" y="7842442"/>
            <a:ext cx="969222" cy="4504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2193502" y="7842442"/>
            <a:ext cx="714163" cy="45049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7924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18" y="4912819"/>
            <a:ext cx="2520000" cy="1368000"/>
          </a:xfrm>
          <a:prstGeom prst="rect">
            <a:avLst/>
          </a:prstGeom>
        </p:spPr>
      </p:pic>
      <p:pic>
        <p:nvPicPr>
          <p:cNvPr id="5" name="Grafik 4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18" y="2735524"/>
            <a:ext cx="2520000" cy="1368000"/>
          </a:xfrm>
          <a:prstGeom prst="rect">
            <a:avLst/>
          </a:prstGeom>
        </p:spPr>
      </p:pic>
      <p:pic>
        <p:nvPicPr>
          <p:cNvPr id="4" name="Grafik 3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218" y="464981"/>
            <a:ext cx="2520000" cy="136800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 rot="16200000">
            <a:off x="-540921" y="1015667"/>
            <a:ext cx="13965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L12 (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ml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323513" y="1697994"/>
            <a:ext cx="1393661" cy="419061"/>
            <a:chOff x="323513" y="1666368"/>
            <a:chExt cx="1393661" cy="419061"/>
          </a:xfrm>
        </p:grpSpPr>
        <p:sp>
          <p:nvSpPr>
            <p:cNvPr id="16" name="Textfeld 15"/>
            <p:cNvSpPr txBox="1"/>
            <p:nvPr/>
          </p:nvSpPr>
          <p:spPr>
            <a:xfrm rot="18900000">
              <a:off x="323513" y="168581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8900000">
              <a:off x="673569" y="16663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 rot="18900000">
              <a:off x="556017" y="1854597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 rot="18900000">
              <a:off x="904131" y="1830116"/>
              <a:ext cx="8130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3" name="Textfeld 182"/>
          <p:cNvSpPr txBox="1"/>
          <p:nvPr/>
        </p:nvSpPr>
        <p:spPr>
          <a:xfrm>
            <a:off x="-25248" y="507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feld 183"/>
          <p:cNvSpPr txBox="1"/>
          <p:nvPr/>
        </p:nvSpPr>
        <p:spPr>
          <a:xfrm>
            <a:off x="1418807" y="249446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L12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141" name="Gruppieren 140"/>
          <p:cNvGrpSpPr/>
          <p:nvPr/>
        </p:nvGrpSpPr>
        <p:grpSpPr>
          <a:xfrm>
            <a:off x="1218320" y="736200"/>
            <a:ext cx="303288" cy="276999"/>
            <a:chOff x="587828" y="728721"/>
            <a:chExt cx="303288" cy="276999"/>
          </a:xfrm>
        </p:grpSpPr>
        <p:cxnSp>
          <p:nvCxnSpPr>
            <p:cNvPr id="142" name="Gerade Verbindung 141"/>
            <p:cNvCxnSpPr/>
            <p:nvPr/>
          </p:nvCxnSpPr>
          <p:spPr>
            <a:xfrm>
              <a:off x="603089" y="914119"/>
              <a:ext cx="27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xtfeld 144"/>
            <p:cNvSpPr txBox="1"/>
            <p:nvPr/>
          </p:nvSpPr>
          <p:spPr>
            <a:xfrm>
              <a:off x="587828" y="728721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2" name="Gruppieren 151"/>
          <p:cNvGrpSpPr/>
          <p:nvPr/>
        </p:nvGrpSpPr>
        <p:grpSpPr>
          <a:xfrm>
            <a:off x="616722" y="749027"/>
            <a:ext cx="540000" cy="276999"/>
            <a:chOff x="858463" y="553023"/>
            <a:chExt cx="540000" cy="276999"/>
          </a:xfrm>
        </p:grpSpPr>
        <p:cxnSp>
          <p:nvCxnSpPr>
            <p:cNvPr id="153" name="Gerade Verbindung 152"/>
            <p:cNvCxnSpPr/>
            <p:nvPr/>
          </p:nvCxnSpPr>
          <p:spPr>
            <a:xfrm>
              <a:off x="858463" y="727799"/>
              <a:ext cx="5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feld 153"/>
            <p:cNvSpPr txBox="1"/>
            <p:nvPr/>
          </p:nvSpPr>
          <p:spPr>
            <a:xfrm>
              <a:off x="919807" y="553023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0" name="Textfeld 129"/>
          <p:cNvSpPr txBox="1"/>
          <p:nvPr/>
        </p:nvSpPr>
        <p:spPr>
          <a:xfrm>
            <a:off x="250495" y="508965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feld 133"/>
          <p:cNvSpPr txBox="1"/>
          <p:nvPr/>
        </p:nvSpPr>
        <p:spPr>
          <a:xfrm>
            <a:off x="250495" y="1534510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250495" y="127812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250495" y="1021737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Gruppieren 61"/>
          <p:cNvGrpSpPr/>
          <p:nvPr/>
        </p:nvGrpSpPr>
        <p:grpSpPr>
          <a:xfrm>
            <a:off x="2335138" y="700311"/>
            <a:ext cx="319318" cy="230832"/>
            <a:chOff x="579812" y="705861"/>
            <a:chExt cx="319318" cy="230832"/>
          </a:xfrm>
        </p:grpSpPr>
        <p:cxnSp>
          <p:nvCxnSpPr>
            <p:cNvPr id="63" name="Gerade Verbindung 62"/>
            <p:cNvCxnSpPr/>
            <p:nvPr/>
          </p:nvCxnSpPr>
          <p:spPr>
            <a:xfrm>
              <a:off x="603089" y="914119"/>
              <a:ext cx="27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feld 63"/>
            <p:cNvSpPr txBox="1"/>
            <p:nvPr/>
          </p:nvSpPr>
          <p:spPr>
            <a:xfrm>
              <a:off x="579812" y="705861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Gruppieren 64"/>
          <p:cNvGrpSpPr/>
          <p:nvPr/>
        </p:nvGrpSpPr>
        <p:grpSpPr>
          <a:xfrm>
            <a:off x="1869688" y="992867"/>
            <a:ext cx="540000" cy="276999"/>
            <a:chOff x="858463" y="553023"/>
            <a:chExt cx="540000" cy="276999"/>
          </a:xfrm>
        </p:grpSpPr>
        <p:cxnSp>
          <p:nvCxnSpPr>
            <p:cNvPr id="66" name="Gerade Verbindung 65"/>
            <p:cNvCxnSpPr/>
            <p:nvPr/>
          </p:nvCxnSpPr>
          <p:spPr>
            <a:xfrm>
              <a:off x="858463" y="727799"/>
              <a:ext cx="5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feld 66"/>
            <p:cNvSpPr txBox="1"/>
            <p:nvPr/>
          </p:nvSpPr>
          <p:spPr>
            <a:xfrm>
              <a:off x="997385" y="553023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8" name="Textfeld 67"/>
          <p:cNvSpPr txBox="1"/>
          <p:nvPr/>
        </p:nvSpPr>
        <p:spPr>
          <a:xfrm>
            <a:off x="714989" y="434208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2056817" y="434208"/>
            <a:ext cx="955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.i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 rot="16200000">
            <a:off x="-547333" y="3352107"/>
            <a:ext cx="14093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XCL9 (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ml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1424137" y="2515354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84" name="Gruppieren 83"/>
          <p:cNvGrpSpPr/>
          <p:nvPr/>
        </p:nvGrpSpPr>
        <p:grpSpPr>
          <a:xfrm>
            <a:off x="1176890" y="2911559"/>
            <a:ext cx="319318" cy="253915"/>
            <a:chOff x="579813" y="709560"/>
            <a:chExt cx="319318" cy="253915"/>
          </a:xfrm>
        </p:grpSpPr>
        <p:cxnSp>
          <p:nvCxnSpPr>
            <p:cNvPr id="85" name="Gerade Verbindung 84"/>
            <p:cNvCxnSpPr/>
            <p:nvPr/>
          </p:nvCxnSpPr>
          <p:spPr>
            <a:xfrm>
              <a:off x="603089" y="914119"/>
              <a:ext cx="27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feld 85"/>
            <p:cNvSpPr txBox="1"/>
            <p:nvPr/>
          </p:nvSpPr>
          <p:spPr>
            <a:xfrm>
              <a:off x="579813" y="709560"/>
              <a:ext cx="319318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Gruppieren 86"/>
          <p:cNvGrpSpPr/>
          <p:nvPr/>
        </p:nvGrpSpPr>
        <p:grpSpPr>
          <a:xfrm>
            <a:off x="604022" y="3269059"/>
            <a:ext cx="540000" cy="276999"/>
            <a:chOff x="858463" y="560643"/>
            <a:chExt cx="540000" cy="276999"/>
          </a:xfrm>
        </p:grpSpPr>
        <p:cxnSp>
          <p:nvCxnSpPr>
            <p:cNvPr id="88" name="Gerade Verbindung 87"/>
            <p:cNvCxnSpPr/>
            <p:nvPr/>
          </p:nvCxnSpPr>
          <p:spPr>
            <a:xfrm>
              <a:off x="858463" y="727799"/>
              <a:ext cx="5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feld 88"/>
            <p:cNvSpPr txBox="1"/>
            <p:nvPr/>
          </p:nvSpPr>
          <p:spPr>
            <a:xfrm>
              <a:off x="1013787" y="560643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Gruppieren 94"/>
          <p:cNvGrpSpPr/>
          <p:nvPr/>
        </p:nvGrpSpPr>
        <p:grpSpPr>
          <a:xfrm>
            <a:off x="2473035" y="2909451"/>
            <a:ext cx="319318" cy="230832"/>
            <a:chOff x="579812" y="705861"/>
            <a:chExt cx="319318" cy="230832"/>
          </a:xfrm>
        </p:grpSpPr>
        <p:cxnSp>
          <p:nvCxnSpPr>
            <p:cNvPr id="96" name="Gerade Verbindung 95"/>
            <p:cNvCxnSpPr/>
            <p:nvPr/>
          </p:nvCxnSpPr>
          <p:spPr>
            <a:xfrm>
              <a:off x="603089" y="914119"/>
              <a:ext cx="27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feld 96"/>
            <p:cNvSpPr txBox="1"/>
            <p:nvPr/>
          </p:nvSpPr>
          <p:spPr>
            <a:xfrm>
              <a:off x="579812" y="705861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Gruppieren 97"/>
          <p:cNvGrpSpPr/>
          <p:nvPr/>
        </p:nvGrpSpPr>
        <p:grpSpPr>
          <a:xfrm>
            <a:off x="1863338" y="2896810"/>
            <a:ext cx="540000" cy="276999"/>
            <a:chOff x="858463" y="553023"/>
            <a:chExt cx="540000" cy="276999"/>
          </a:xfrm>
        </p:grpSpPr>
        <p:cxnSp>
          <p:nvCxnSpPr>
            <p:cNvPr id="99" name="Gerade Verbindung 98"/>
            <p:cNvCxnSpPr/>
            <p:nvPr/>
          </p:nvCxnSpPr>
          <p:spPr>
            <a:xfrm>
              <a:off x="858463" y="727799"/>
              <a:ext cx="5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feld 99"/>
            <p:cNvSpPr txBox="1"/>
            <p:nvPr/>
          </p:nvSpPr>
          <p:spPr>
            <a:xfrm>
              <a:off x="964257" y="553023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Textfeld 100"/>
          <p:cNvSpPr txBox="1"/>
          <p:nvPr/>
        </p:nvSpPr>
        <p:spPr>
          <a:xfrm>
            <a:off x="720319" y="2700116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2062147" y="2700116"/>
            <a:ext cx="955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.i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255825" y="277487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255825" y="380041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59645" y="359530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/>
          <p:cNvSpPr txBox="1"/>
          <p:nvPr/>
        </p:nvSpPr>
        <p:spPr>
          <a:xfrm>
            <a:off x="159645" y="2979982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159645" y="3390200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uppieren 23"/>
          <p:cNvGrpSpPr/>
          <p:nvPr/>
        </p:nvGrpSpPr>
        <p:grpSpPr>
          <a:xfrm>
            <a:off x="95525" y="4950767"/>
            <a:ext cx="409086" cy="1256377"/>
            <a:chOff x="247925" y="4990534"/>
            <a:chExt cx="409086" cy="1256377"/>
          </a:xfrm>
        </p:grpSpPr>
        <p:sp>
          <p:nvSpPr>
            <p:cNvPr id="105" name="Textfeld 104"/>
            <p:cNvSpPr txBox="1"/>
            <p:nvPr/>
          </p:nvSpPr>
          <p:spPr>
            <a:xfrm>
              <a:off x="312045" y="4990534"/>
              <a:ext cx="3449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feld 105"/>
            <p:cNvSpPr txBox="1"/>
            <p:nvPr/>
          </p:nvSpPr>
          <p:spPr>
            <a:xfrm>
              <a:off x="408225" y="6016079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feld 106"/>
            <p:cNvSpPr txBox="1"/>
            <p:nvPr/>
          </p:nvSpPr>
          <p:spPr>
            <a:xfrm>
              <a:off x="247925" y="560586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247925" y="5195643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8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feld 108"/>
            <p:cNvSpPr txBox="1"/>
            <p:nvPr/>
          </p:nvSpPr>
          <p:spPr>
            <a:xfrm>
              <a:off x="247925" y="5400752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6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feld 109"/>
            <p:cNvSpPr txBox="1"/>
            <p:nvPr/>
          </p:nvSpPr>
          <p:spPr>
            <a:xfrm>
              <a:off x="247925" y="581097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4" name="Textfeld 113"/>
          <p:cNvSpPr txBox="1"/>
          <p:nvPr/>
        </p:nvSpPr>
        <p:spPr>
          <a:xfrm rot="16200000">
            <a:off x="-572485" y="5436381"/>
            <a:ext cx="13580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de-DE" sz="9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ml </a:t>
            </a:r>
            <a:r>
              <a:rPr lang="de-DE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1416517" y="4739218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de-DE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126" name="Gruppieren 125"/>
          <p:cNvGrpSpPr/>
          <p:nvPr/>
        </p:nvGrpSpPr>
        <p:grpSpPr>
          <a:xfrm>
            <a:off x="1183240" y="5581441"/>
            <a:ext cx="319318" cy="230832"/>
            <a:chOff x="579813" y="713481"/>
            <a:chExt cx="319318" cy="230832"/>
          </a:xfrm>
        </p:grpSpPr>
        <p:cxnSp>
          <p:nvCxnSpPr>
            <p:cNvPr id="127" name="Gerade Verbindung 126"/>
            <p:cNvCxnSpPr/>
            <p:nvPr/>
          </p:nvCxnSpPr>
          <p:spPr>
            <a:xfrm>
              <a:off x="603089" y="914119"/>
              <a:ext cx="27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feld 131"/>
            <p:cNvSpPr txBox="1"/>
            <p:nvPr/>
          </p:nvSpPr>
          <p:spPr>
            <a:xfrm>
              <a:off x="579813" y="713481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9" name="Textfeld 158"/>
          <p:cNvSpPr txBox="1"/>
          <p:nvPr/>
        </p:nvSpPr>
        <p:spPr>
          <a:xfrm>
            <a:off x="712699" y="4923980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60" name="Textfeld 159"/>
          <p:cNvSpPr txBox="1"/>
          <p:nvPr/>
        </p:nvSpPr>
        <p:spPr>
          <a:xfrm>
            <a:off x="2054527" y="4923980"/>
            <a:ext cx="955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.i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167" name="Gruppieren 166"/>
          <p:cNvGrpSpPr/>
          <p:nvPr/>
        </p:nvGrpSpPr>
        <p:grpSpPr>
          <a:xfrm>
            <a:off x="635772" y="5698787"/>
            <a:ext cx="540000" cy="230832"/>
            <a:chOff x="858463" y="527623"/>
            <a:chExt cx="540000" cy="230832"/>
          </a:xfrm>
        </p:grpSpPr>
        <p:cxnSp>
          <p:nvCxnSpPr>
            <p:cNvPr id="168" name="Gerade Verbindung 167"/>
            <p:cNvCxnSpPr/>
            <p:nvPr/>
          </p:nvCxnSpPr>
          <p:spPr>
            <a:xfrm>
              <a:off x="858463" y="727799"/>
              <a:ext cx="5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feld 168"/>
            <p:cNvSpPr txBox="1"/>
            <p:nvPr/>
          </p:nvSpPr>
          <p:spPr>
            <a:xfrm>
              <a:off x="982037" y="527623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1" name="Textfeld 110"/>
          <p:cNvSpPr txBox="1"/>
          <p:nvPr/>
        </p:nvSpPr>
        <p:spPr>
          <a:xfrm>
            <a:off x="250495" y="76535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159645" y="3185091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8" name="Gruppieren 127"/>
          <p:cNvGrpSpPr/>
          <p:nvPr/>
        </p:nvGrpSpPr>
        <p:grpSpPr>
          <a:xfrm>
            <a:off x="2359500" y="5213399"/>
            <a:ext cx="319318" cy="230832"/>
            <a:chOff x="579813" y="713481"/>
            <a:chExt cx="319318" cy="230832"/>
          </a:xfrm>
        </p:grpSpPr>
        <p:cxnSp>
          <p:nvCxnSpPr>
            <p:cNvPr id="129" name="Gerade Verbindung 128"/>
            <p:cNvCxnSpPr/>
            <p:nvPr/>
          </p:nvCxnSpPr>
          <p:spPr>
            <a:xfrm>
              <a:off x="603089" y="914119"/>
              <a:ext cx="27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feld 130"/>
            <p:cNvSpPr txBox="1"/>
            <p:nvPr/>
          </p:nvSpPr>
          <p:spPr>
            <a:xfrm>
              <a:off x="579813" y="713481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3" name="Gruppieren 132"/>
          <p:cNvGrpSpPr/>
          <p:nvPr/>
        </p:nvGrpSpPr>
        <p:grpSpPr>
          <a:xfrm>
            <a:off x="1850132" y="5570011"/>
            <a:ext cx="540000" cy="230832"/>
            <a:chOff x="858463" y="527623"/>
            <a:chExt cx="540000" cy="230832"/>
          </a:xfrm>
        </p:grpSpPr>
        <p:cxnSp>
          <p:nvCxnSpPr>
            <p:cNvPr id="136" name="Gerade Verbindung 135"/>
            <p:cNvCxnSpPr/>
            <p:nvPr/>
          </p:nvCxnSpPr>
          <p:spPr>
            <a:xfrm>
              <a:off x="858463" y="727799"/>
              <a:ext cx="5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feld 136"/>
            <p:cNvSpPr txBox="1"/>
            <p:nvPr/>
          </p:nvSpPr>
          <p:spPr>
            <a:xfrm>
              <a:off x="982037" y="527623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3" name="Gruppieren 112"/>
          <p:cNvGrpSpPr/>
          <p:nvPr/>
        </p:nvGrpSpPr>
        <p:grpSpPr>
          <a:xfrm>
            <a:off x="1490092" y="1697994"/>
            <a:ext cx="1393661" cy="419061"/>
            <a:chOff x="323513" y="1666368"/>
            <a:chExt cx="1393661" cy="419061"/>
          </a:xfrm>
        </p:grpSpPr>
        <p:sp>
          <p:nvSpPr>
            <p:cNvPr id="138" name="Textfeld 137"/>
            <p:cNvSpPr txBox="1"/>
            <p:nvPr/>
          </p:nvSpPr>
          <p:spPr>
            <a:xfrm rot="18900000">
              <a:off x="323513" y="168581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feld 138"/>
            <p:cNvSpPr txBox="1"/>
            <p:nvPr/>
          </p:nvSpPr>
          <p:spPr>
            <a:xfrm rot="18900000">
              <a:off x="673569" y="16663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feld 139"/>
            <p:cNvSpPr txBox="1"/>
            <p:nvPr/>
          </p:nvSpPr>
          <p:spPr>
            <a:xfrm rot="18900000">
              <a:off x="556017" y="1854597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feld 142"/>
            <p:cNvSpPr txBox="1"/>
            <p:nvPr/>
          </p:nvSpPr>
          <p:spPr>
            <a:xfrm rot="18900000">
              <a:off x="904131" y="1830116"/>
              <a:ext cx="8130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4" name="Gruppieren 143"/>
          <p:cNvGrpSpPr/>
          <p:nvPr/>
        </p:nvGrpSpPr>
        <p:grpSpPr>
          <a:xfrm>
            <a:off x="306214" y="3951450"/>
            <a:ext cx="1393661" cy="419061"/>
            <a:chOff x="323513" y="1666368"/>
            <a:chExt cx="1393661" cy="419061"/>
          </a:xfrm>
        </p:grpSpPr>
        <p:sp>
          <p:nvSpPr>
            <p:cNvPr id="148" name="Textfeld 147"/>
            <p:cNvSpPr txBox="1"/>
            <p:nvPr/>
          </p:nvSpPr>
          <p:spPr>
            <a:xfrm rot="18900000">
              <a:off x="323513" y="168581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feld 148"/>
            <p:cNvSpPr txBox="1"/>
            <p:nvPr/>
          </p:nvSpPr>
          <p:spPr>
            <a:xfrm rot="18900000">
              <a:off x="673569" y="16663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feld 149"/>
            <p:cNvSpPr txBox="1"/>
            <p:nvPr/>
          </p:nvSpPr>
          <p:spPr>
            <a:xfrm rot="18900000">
              <a:off x="556017" y="1854597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feld 150"/>
            <p:cNvSpPr txBox="1"/>
            <p:nvPr/>
          </p:nvSpPr>
          <p:spPr>
            <a:xfrm rot="18900000">
              <a:off x="904131" y="1830116"/>
              <a:ext cx="8130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5" name="Gruppieren 154"/>
          <p:cNvGrpSpPr/>
          <p:nvPr/>
        </p:nvGrpSpPr>
        <p:grpSpPr>
          <a:xfrm>
            <a:off x="1504841" y="3951450"/>
            <a:ext cx="1393661" cy="419061"/>
            <a:chOff x="323513" y="1666368"/>
            <a:chExt cx="1393661" cy="419061"/>
          </a:xfrm>
        </p:grpSpPr>
        <p:sp>
          <p:nvSpPr>
            <p:cNvPr id="156" name="Textfeld 155"/>
            <p:cNvSpPr txBox="1"/>
            <p:nvPr/>
          </p:nvSpPr>
          <p:spPr>
            <a:xfrm rot="18900000">
              <a:off x="323513" y="168581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feld 156"/>
            <p:cNvSpPr txBox="1"/>
            <p:nvPr/>
          </p:nvSpPr>
          <p:spPr>
            <a:xfrm rot="18900000">
              <a:off x="673569" y="16663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feld 157"/>
            <p:cNvSpPr txBox="1"/>
            <p:nvPr/>
          </p:nvSpPr>
          <p:spPr>
            <a:xfrm rot="18900000">
              <a:off x="556017" y="1854597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feld 160"/>
            <p:cNvSpPr txBox="1"/>
            <p:nvPr/>
          </p:nvSpPr>
          <p:spPr>
            <a:xfrm rot="18900000">
              <a:off x="904131" y="1830116"/>
              <a:ext cx="8130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2" name="Gruppieren 161"/>
          <p:cNvGrpSpPr/>
          <p:nvPr/>
        </p:nvGrpSpPr>
        <p:grpSpPr>
          <a:xfrm>
            <a:off x="299864" y="6128582"/>
            <a:ext cx="1393661" cy="419061"/>
            <a:chOff x="323513" y="1666368"/>
            <a:chExt cx="1393661" cy="419061"/>
          </a:xfrm>
        </p:grpSpPr>
        <p:sp>
          <p:nvSpPr>
            <p:cNvPr id="163" name="Textfeld 162"/>
            <p:cNvSpPr txBox="1"/>
            <p:nvPr/>
          </p:nvSpPr>
          <p:spPr>
            <a:xfrm rot="18900000">
              <a:off x="323513" y="168581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feld 163"/>
            <p:cNvSpPr txBox="1"/>
            <p:nvPr/>
          </p:nvSpPr>
          <p:spPr>
            <a:xfrm rot="18900000">
              <a:off x="673569" y="16663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feld 164"/>
            <p:cNvSpPr txBox="1"/>
            <p:nvPr/>
          </p:nvSpPr>
          <p:spPr>
            <a:xfrm rot="18900000">
              <a:off x="556017" y="1854597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feld 165"/>
            <p:cNvSpPr txBox="1"/>
            <p:nvPr/>
          </p:nvSpPr>
          <p:spPr>
            <a:xfrm rot="18900000">
              <a:off x="904131" y="1830116"/>
              <a:ext cx="8130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0" name="Gruppieren 169"/>
          <p:cNvGrpSpPr/>
          <p:nvPr/>
        </p:nvGrpSpPr>
        <p:grpSpPr>
          <a:xfrm>
            <a:off x="1511191" y="6128582"/>
            <a:ext cx="1393661" cy="419061"/>
            <a:chOff x="323513" y="1666368"/>
            <a:chExt cx="1393661" cy="419061"/>
          </a:xfrm>
        </p:grpSpPr>
        <p:sp>
          <p:nvSpPr>
            <p:cNvPr id="171" name="Textfeld 170"/>
            <p:cNvSpPr txBox="1"/>
            <p:nvPr/>
          </p:nvSpPr>
          <p:spPr>
            <a:xfrm rot="18900000">
              <a:off x="323513" y="168581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feld 171"/>
            <p:cNvSpPr txBox="1"/>
            <p:nvPr/>
          </p:nvSpPr>
          <p:spPr>
            <a:xfrm rot="18900000">
              <a:off x="673569" y="1666368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feld 172"/>
            <p:cNvSpPr txBox="1"/>
            <p:nvPr/>
          </p:nvSpPr>
          <p:spPr>
            <a:xfrm rot="18900000">
              <a:off x="556017" y="1854597"/>
              <a:ext cx="8771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Textfeld 173"/>
            <p:cNvSpPr txBox="1"/>
            <p:nvPr/>
          </p:nvSpPr>
          <p:spPr>
            <a:xfrm rot="18900000">
              <a:off x="904131" y="1830116"/>
              <a:ext cx="8130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DL-MCMV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8742973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Benutzerdefiniert</PresentationFormat>
  <Paragraphs>67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KS</dc:creator>
  <cp:lastModifiedBy>alzi</cp:lastModifiedBy>
  <cp:revision>37</cp:revision>
  <cp:lastPrinted>2017-07-04T11:28:44Z</cp:lastPrinted>
  <dcterms:created xsi:type="dcterms:W3CDTF">2016-11-18T13:06:40Z</dcterms:created>
  <dcterms:modified xsi:type="dcterms:W3CDTF">2018-06-12T17:29:40Z</dcterms:modified>
</cp:coreProperties>
</file>